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74" autoAdjust="0"/>
    <p:restoredTop sz="94660"/>
  </p:normalViewPr>
  <p:slideViewPr>
    <p:cSldViewPr snapToGrid="0">
      <p:cViewPr varScale="1">
        <p:scale>
          <a:sx n="82" d="100"/>
          <a:sy n="82" d="100"/>
        </p:scale>
        <p:origin x="67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IGOR\Papers\SUBMITTED%20OR%20ALMOST%20READY%20TO\Mariia%20cytokine%20paper\Figur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CA" sz="2000" dirty="0"/>
              <a:t>Cytokine levels by ELIS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2431223246301"/>
          <c:y val="2.5428331875182269E-2"/>
          <c:w val="0.87756877675369904"/>
          <c:h val="0.7763049763509413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3</c:f>
              <c:strCache>
                <c:ptCount val="1"/>
                <c:pt idx="0">
                  <c:v>IL-1b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C$2:$F$2</c:f>
              <c:strCache>
                <c:ptCount val="4"/>
                <c:pt idx="0">
                  <c:v>LPS media</c:v>
                </c:pt>
                <c:pt idx="1">
                  <c:v>Ct media</c:v>
                </c:pt>
                <c:pt idx="2">
                  <c:v>LPS cell lysate</c:v>
                </c:pt>
                <c:pt idx="3">
                  <c:v>Ct cell lysate</c:v>
                </c:pt>
              </c:strCache>
            </c:strRef>
          </c:cat>
          <c:val>
            <c:numRef>
              <c:f>Sheet1!$C$3:$F$3</c:f>
              <c:numCache>
                <c:formatCode>General</c:formatCode>
                <c:ptCount val="4"/>
                <c:pt idx="0">
                  <c:v>1635.39</c:v>
                </c:pt>
                <c:pt idx="1">
                  <c:v>21.51</c:v>
                </c:pt>
                <c:pt idx="2">
                  <c:v>224.67</c:v>
                </c:pt>
                <c:pt idx="3">
                  <c:v>54.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8FA-4475-82C0-0672A2DEB860}"/>
            </c:ext>
          </c:extLst>
        </c:ser>
        <c:ser>
          <c:idx val="1"/>
          <c:order val="1"/>
          <c:tx>
            <c:strRef>
              <c:f>Sheet1!$B$4</c:f>
              <c:strCache>
                <c:ptCount val="1"/>
                <c:pt idx="0">
                  <c:v>TNF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C$2:$F$2</c:f>
              <c:strCache>
                <c:ptCount val="4"/>
                <c:pt idx="0">
                  <c:v>LPS media</c:v>
                </c:pt>
                <c:pt idx="1">
                  <c:v>Ct media</c:v>
                </c:pt>
                <c:pt idx="2">
                  <c:v>LPS cell lysate</c:v>
                </c:pt>
                <c:pt idx="3">
                  <c:v>Ct cell lysate</c:v>
                </c:pt>
              </c:strCache>
            </c:strRef>
          </c:cat>
          <c:val>
            <c:numRef>
              <c:f>Sheet1!$C$4:$F$4</c:f>
              <c:numCache>
                <c:formatCode>General</c:formatCode>
                <c:ptCount val="4"/>
                <c:pt idx="0">
                  <c:v>4202.42</c:v>
                </c:pt>
                <c:pt idx="1">
                  <c:v>6.46</c:v>
                </c:pt>
                <c:pt idx="2">
                  <c:v>2168.15</c:v>
                </c:pt>
                <c:pt idx="3">
                  <c:v>7.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8FA-4475-82C0-0672A2DEB860}"/>
            </c:ext>
          </c:extLst>
        </c:ser>
        <c:ser>
          <c:idx val="2"/>
          <c:order val="2"/>
          <c:tx>
            <c:strRef>
              <c:f>Sheet1!$B$5</c:f>
              <c:strCache>
                <c:ptCount val="1"/>
                <c:pt idx="0">
                  <c:v>IL-10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C$2:$F$2</c:f>
              <c:strCache>
                <c:ptCount val="4"/>
                <c:pt idx="0">
                  <c:v>LPS media</c:v>
                </c:pt>
                <c:pt idx="1">
                  <c:v>Ct media</c:v>
                </c:pt>
                <c:pt idx="2">
                  <c:v>LPS cell lysate</c:v>
                </c:pt>
                <c:pt idx="3">
                  <c:v>Ct cell lysate</c:v>
                </c:pt>
              </c:strCache>
            </c:strRef>
          </c:cat>
          <c:val>
            <c:numRef>
              <c:f>Sheet1!$C$5:$F$5</c:f>
              <c:numCache>
                <c:formatCode>General</c:formatCode>
                <c:ptCount val="4"/>
                <c:pt idx="0">
                  <c:v>625.17999999999995</c:v>
                </c:pt>
                <c:pt idx="1">
                  <c:v>20.37</c:v>
                </c:pt>
                <c:pt idx="2">
                  <c:v>3.57</c:v>
                </c:pt>
                <c:pt idx="3">
                  <c:v>5.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8FA-4475-82C0-0672A2DEB8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82695360"/>
        <c:axId val="1982701184"/>
      </c:barChart>
      <c:catAx>
        <c:axId val="1982695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2701184"/>
        <c:crosses val="autoZero"/>
        <c:auto val="1"/>
        <c:lblAlgn val="ctr"/>
        <c:lblOffset val="100"/>
        <c:noMultiLvlLbl val="0"/>
      </c:catAx>
      <c:valAx>
        <c:axId val="198270118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26953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9151516309988158"/>
          <c:y val="0.19154212026363845"/>
          <c:w val="0.45124724100283009"/>
          <c:h val="7.981733692304908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 b="1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308BDE-029F-F87C-6C93-C509E14222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1F321FD-D9A5-D8BB-4249-5BBA8CF44A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25C340-3357-2B64-8523-FB9417734E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3CE92-3EA8-4D4A-892B-5A6E8E03A08F}" type="datetimeFigureOut">
              <a:rPr lang="en-CA" smtClean="0"/>
              <a:t>2023-06-24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251CFD-C7D3-D665-5535-5AD81A9989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109EB9-6079-B603-B37B-8459284B7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F406-94F2-4617-A79D-69A69F7DFFC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443998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AF92E2-AB60-03DE-0AD8-EADCA282B1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E847BF-82C2-E5AF-8137-AED692EA06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404B61-F056-3623-CA86-5A197AC68A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3CE92-3EA8-4D4A-892B-5A6E8E03A08F}" type="datetimeFigureOut">
              <a:rPr lang="en-CA" smtClean="0"/>
              <a:t>2023-06-24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BD0CF9-B8C6-D907-13A1-C3FF1ABA10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80890A-82D4-6F9C-BB8A-E66EF3BA0A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F406-94F2-4617-A79D-69A69F7DFFC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16321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9C727E0-677F-8016-812F-27ACA27346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9F16AED-4352-8229-1194-D753D92058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B238F0-34D1-3440-E901-56568A36B9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3CE92-3EA8-4D4A-892B-5A6E8E03A08F}" type="datetimeFigureOut">
              <a:rPr lang="en-CA" smtClean="0"/>
              <a:t>2023-06-24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84923A-33BD-CFA5-2B72-B89BA5964D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57CDB7-368C-2020-814B-F63297D419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F406-94F2-4617-A79D-69A69F7DFFC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63892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39566F-4364-6CCF-5034-31C8EE0546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5D815F-C89D-325B-836D-D61F894F26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19822B-0A0E-4947-CE65-D936D01776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3CE92-3EA8-4D4A-892B-5A6E8E03A08F}" type="datetimeFigureOut">
              <a:rPr lang="en-CA" smtClean="0"/>
              <a:t>2023-06-24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548075-2213-2EC1-E48B-9B2E001540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A02D99-CEC1-745C-26D8-CD0C28ABDF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F406-94F2-4617-A79D-69A69F7DFFC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86995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E57D12-6C40-0FF0-BDBF-2359D2C782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498D5F-5559-113C-137B-29411024AB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5E7BB5-C538-8406-E782-29AD28C58C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3CE92-3EA8-4D4A-892B-5A6E8E03A08F}" type="datetimeFigureOut">
              <a:rPr lang="en-CA" smtClean="0"/>
              <a:t>2023-06-24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CA8C48-FEAF-7A9A-F8E2-98533F2048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EF6757-854A-1DEE-AA95-05B8E98F4D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F406-94F2-4617-A79D-69A69F7DFFC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064848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C7E0F5-8712-9E90-9A84-D93376D06A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F6371A-AF85-C4FE-B267-5A12603966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D968D3-0ED7-B5AA-CFE8-DFEB99BFDC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335194-7CD9-E518-274F-8E5C4B039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3CE92-3EA8-4D4A-892B-5A6E8E03A08F}" type="datetimeFigureOut">
              <a:rPr lang="en-CA" smtClean="0"/>
              <a:t>2023-06-24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85925E-F179-2287-4DB0-2C013840C8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E5A539-9991-09E6-8A9D-63F861DEFA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F406-94F2-4617-A79D-69A69F7DFFC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114459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8B3EF8-49B9-E2D4-2283-22AAC390BC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2C1376-09FB-576E-3FC8-DB7B82F0C7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EF1F986-C8E8-24D9-8F92-FE321CE882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04734E8-88B9-1CD6-4B13-C9E9B1B652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2D2F641-12BA-9194-A535-3474DC9EE7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390843F-A30B-0A74-6403-20B77A55ED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3CE92-3EA8-4D4A-892B-5A6E8E03A08F}" type="datetimeFigureOut">
              <a:rPr lang="en-CA" smtClean="0"/>
              <a:t>2023-06-24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25206F7-D5BA-61D5-073F-24406F46BD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96DD5C4-24C5-A706-2FF7-A6FA6812BD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F406-94F2-4617-A79D-69A69F7DFFC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248233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3D1858-27E6-7FA5-5071-D2F8074E88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8DA9647-47FF-D53C-EA40-14467FCB1D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3CE92-3EA8-4D4A-892B-5A6E8E03A08F}" type="datetimeFigureOut">
              <a:rPr lang="en-CA" smtClean="0"/>
              <a:t>2023-06-24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3CE60F8-0E23-79E2-8F97-0A76481CE5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04D8DD-8F79-06E6-5CF0-BE06EF96A7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F406-94F2-4617-A79D-69A69F7DFFC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9137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6CD7C85-2DCA-2740-C357-7ACE017ABB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3CE92-3EA8-4D4A-892B-5A6E8E03A08F}" type="datetimeFigureOut">
              <a:rPr lang="en-CA" smtClean="0"/>
              <a:t>2023-06-24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E77DA67-2586-23CA-9C12-3111EED648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5371B3E-AAF7-D8C5-7726-E761137E6F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F406-94F2-4617-A79D-69A69F7DFFC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017328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C5E958-CB9D-7400-DB55-B788B867E8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C669D4-B96C-4AB5-9551-8AA7B74986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8E8E8E-4165-AF07-B3A6-A7C9F4970A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89F713-7279-3DE5-9555-3B099C7E80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3CE92-3EA8-4D4A-892B-5A6E8E03A08F}" type="datetimeFigureOut">
              <a:rPr lang="en-CA" smtClean="0"/>
              <a:t>2023-06-24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D1407A-8991-C454-5697-5DA35AC701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8C75D2-419A-7C76-865A-ED11B5B044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F406-94F2-4617-A79D-69A69F7DFFC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73461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75046D-E426-F658-FA05-67F04278FE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3E2EDB9-C59E-EAAD-8D9F-686B6FE5A7A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19859BD-C509-DDC6-FF4E-02DACF18BD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D4335B-BEB8-E329-9904-F3457986E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3CE92-3EA8-4D4A-892B-5A6E8E03A08F}" type="datetimeFigureOut">
              <a:rPr lang="en-CA" smtClean="0"/>
              <a:t>2023-06-24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D7AF5F-A852-AD0E-EC23-B9A36B3490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462534-EADE-24B1-9492-FFCB3E1BE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F406-94F2-4617-A79D-69A69F7DFFC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0478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552D24E-0034-3425-DCDF-F3AC02EC1B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7A00CC-0842-804E-7B0C-DCF1E3AC5F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5A4A5C-2C76-F21C-FCE4-AD430495C3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63CE92-3EA8-4D4A-892B-5A6E8E03A08F}" type="datetimeFigureOut">
              <a:rPr lang="en-CA" smtClean="0"/>
              <a:t>2023-06-24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83B8C4-5D48-18FC-299D-CEE5696CB2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59B923-669E-C9CF-FB63-5D3E0F2BFFA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FFF406-94F2-4617-A79D-69A69F7DFFC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67413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A623DE9F-9A5D-BD55-645E-BA63E806192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3349565"/>
              </p:ext>
            </p:extLst>
          </p:nvPr>
        </p:nvGraphicFramePr>
        <p:xfrm>
          <a:off x="3452571" y="2063165"/>
          <a:ext cx="5114430" cy="29657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D17DBB1E-FAAE-E3E8-E3FE-514F9AD90A8B}"/>
              </a:ext>
            </a:extLst>
          </p:cNvPr>
          <p:cNvSpPr txBox="1"/>
          <p:nvPr/>
        </p:nvSpPr>
        <p:spPr>
          <a:xfrm rot="16200000">
            <a:off x="2277481" y="3022957"/>
            <a:ext cx="1879450" cy="3705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ytokines, pg/ml</a:t>
            </a:r>
            <a:endParaRPr lang="en-CA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D6BB4B2-379F-27C5-7EA4-3059563A5F78}"/>
              </a:ext>
            </a:extLst>
          </p:cNvPr>
          <p:cNvSpPr txBox="1"/>
          <p:nvPr/>
        </p:nvSpPr>
        <p:spPr>
          <a:xfrm>
            <a:off x="10831286" y="5751247"/>
            <a:ext cx="1292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</a:t>
            </a:r>
            <a:endParaRPr lang="en-CA" b="1" dirty="0"/>
          </a:p>
        </p:txBody>
      </p:sp>
    </p:spTree>
    <p:extLst>
      <p:ext uri="{BB962C8B-B14F-4D97-AF65-F5344CB8AC3E}">
        <p14:creationId xmlns:p14="http://schemas.microsoft.com/office/powerpoint/2010/main" val="42624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Рисунок 17">
            <a:extLst>
              <a:ext uri="{FF2B5EF4-FFF2-40B4-BE49-F238E27FC236}">
                <a16:creationId xmlns:a16="http://schemas.microsoft.com/office/drawing/2014/main" id="{5EEA1C61-AB28-1F21-859C-3EC51CD454A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3078" y="1"/>
            <a:ext cx="5153025" cy="4519364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Рисунок 18">
            <a:extLst>
              <a:ext uri="{FF2B5EF4-FFF2-40B4-BE49-F238E27FC236}">
                <a16:creationId xmlns:a16="http://schemas.microsoft.com/office/drawing/2014/main" id="{395FA2C4-F0DB-4545-6175-FC1118C04B0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0286" y="0"/>
            <a:ext cx="5153025" cy="4519295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DD1DDA5-EE43-23A4-CAEE-72BCC835B309}"/>
              </a:ext>
            </a:extLst>
          </p:cNvPr>
          <p:cNvSpPr txBox="1"/>
          <p:nvPr/>
        </p:nvSpPr>
        <p:spPr>
          <a:xfrm>
            <a:off x="8458199" y="5475513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2</a:t>
            </a:r>
            <a:endParaRPr lang="en-CA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579AAD7-BEDF-1E89-A59B-F7C653D555BA}"/>
              </a:ext>
            </a:extLst>
          </p:cNvPr>
          <p:cNvSpPr txBox="1"/>
          <p:nvPr/>
        </p:nvSpPr>
        <p:spPr>
          <a:xfrm>
            <a:off x="948085" y="130630"/>
            <a:ext cx="386644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/>
              <a:t>A</a:t>
            </a:r>
            <a:endParaRPr lang="en-CA" sz="26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2CCF5AD-7C74-E544-5F17-449252CA1A4C}"/>
              </a:ext>
            </a:extLst>
          </p:cNvPr>
          <p:cNvSpPr txBox="1"/>
          <p:nvPr/>
        </p:nvSpPr>
        <p:spPr>
          <a:xfrm>
            <a:off x="6175473" y="130629"/>
            <a:ext cx="372218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/>
              <a:t>B</a:t>
            </a:r>
            <a:endParaRPr lang="en-CA" sz="2600" b="1" dirty="0"/>
          </a:p>
        </p:txBody>
      </p:sp>
    </p:spTree>
    <p:extLst>
      <p:ext uri="{BB962C8B-B14F-4D97-AF65-F5344CB8AC3E}">
        <p14:creationId xmlns:p14="http://schemas.microsoft.com/office/powerpoint/2010/main" val="23197383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42</TotalTime>
  <Words>15</Words>
  <Application>Microsoft Office PowerPoint</Application>
  <PresentationFormat>Widescreen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gor Kovalchuk</dc:creator>
  <cp:lastModifiedBy>Igor Kovalchuk</cp:lastModifiedBy>
  <cp:revision>11</cp:revision>
  <dcterms:created xsi:type="dcterms:W3CDTF">2022-09-07T18:01:05Z</dcterms:created>
  <dcterms:modified xsi:type="dcterms:W3CDTF">2023-06-24T17:36:53Z</dcterms:modified>
</cp:coreProperties>
</file>